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-804" y="-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47EF76-1241-4A03-8E47-6C19A4FC1D52}" type="datetimeFigureOut">
              <a:rPr lang="de-DE" smtClean="0"/>
              <a:t>20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CFF6E-4D21-45EE-A16E-D4959D7C7F5D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/>
          <p:cNvGraphicFramePr>
            <a:graphicFrameLocks noGrp="1"/>
          </p:cNvGraphicFramePr>
          <p:nvPr/>
        </p:nvGraphicFramePr>
        <p:xfrm>
          <a:off x="1475656" y="-7"/>
          <a:ext cx="4896544" cy="6597357"/>
        </p:xfrm>
        <a:graphic>
          <a:graphicData uri="http://schemas.openxmlformats.org/drawingml/2006/table">
            <a:tbl>
              <a:tblPr/>
              <a:tblGrid>
                <a:gridCol w="4352484"/>
                <a:gridCol w="544060"/>
              </a:tblGrid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 dirty="0">
                          <a:latin typeface="Arial"/>
                          <a:ea typeface="Times New Roman"/>
                          <a:cs typeface="Calibri"/>
                        </a:rPr>
                        <a:t>Hypothetical protein, conserved</a:t>
                      </a:r>
                      <a:endParaRPr lang="de-DE" sz="9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87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Hypothetical protein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73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Rifin/stevor famil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49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Conserved </a:t>
                      </a:r>
                      <a:r>
                        <a:rPr lang="en-US" sz="800" i="1">
                          <a:latin typeface="Arial"/>
                          <a:ea typeface="Times New Roman"/>
                          <a:cs typeface="Calibri"/>
                        </a:rPr>
                        <a:t>Plasmodium</a:t>
                      </a: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 protein, unknown function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6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Acid terminal segments, variant surface antigen of PfEMP1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0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rifin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8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 i="1">
                          <a:latin typeface="Arial"/>
                          <a:ea typeface="Times New Roman"/>
                          <a:cs typeface="Calibri"/>
                        </a:rPr>
                        <a:t>Plasmodium</a:t>
                      </a: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 RESA N-terminal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6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Duffy-binding domain containing protein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237490" algn="ctr"/>
                          <a:tab pos="474980" algn="r"/>
                        </a:tabLs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	4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X-domain of DnaJ-containing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2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Tryptophan-Threonine-rich </a:t>
                      </a:r>
                      <a:r>
                        <a:rPr lang="en-US" sz="800" i="1">
                          <a:latin typeface="Arial"/>
                          <a:ea typeface="Times New Roman"/>
                          <a:cs typeface="Calibri"/>
                        </a:rPr>
                        <a:t>Plasmodium</a:t>
                      </a: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 antigen C terminal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2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Probable proetin, unknown function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2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translation machinery-associated protein 7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stevor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RNA-binding protein s1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Reticulon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Protein phosphatase inhibitor 3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 i="1">
                          <a:latin typeface="Arial"/>
                          <a:ea typeface="Times New Roman"/>
                          <a:cs typeface="Calibri"/>
                        </a:rPr>
                        <a:t>Plasmodium</a:t>
                      </a: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 protein of unknown function (Plasmod_dom_1)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 i="1">
                          <a:latin typeface="Arial"/>
                          <a:ea typeface="Times New Roman"/>
                          <a:cs typeface="Calibri"/>
                        </a:rPr>
                        <a:t>Plasmodium</a:t>
                      </a: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 exported protein (PHISTa), unknown function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Mitotic-spindle organizing protein 1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Histidine-rich protein III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Histidine-rich protein II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Early transcribed membrane protein 10.3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563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Duffy binding domain/acidic terminal segments, variant surface antigen of PfEMP1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Dihydrofolate reductase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Conserved protein, unknown function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Apicoplast ribosomal protein S7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Apicoplast ribosomal protein S19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Apicoplast ribosomal protein S1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60S ribosomal protein L41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 dirty="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1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>
                          <a:latin typeface="Arial"/>
                          <a:ea typeface="Times New Roman"/>
                          <a:cs typeface="Calibri"/>
                        </a:rPr>
                        <a:t>60S ribosomal protein L29, putative</a:t>
                      </a:r>
                      <a:endParaRPr lang="de-DE" sz="90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800" dirty="0">
                          <a:latin typeface="Arial"/>
                          <a:ea typeface="Times New Roman"/>
                          <a:cs typeface="Calibri"/>
                        </a:rPr>
                        <a:t>1</a:t>
                      </a:r>
                      <a:endParaRPr lang="de-DE" sz="900" dirty="0">
                        <a:latin typeface="Calibri"/>
                        <a:ea typeface="Times New Roman"/>
                        <a:cs typeface="Calibri"/>
                      </a:endParaRPr>
                    </a:p>
                  </a:txBody>
                  <a:tcPr marL="55799" marR="557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Office PowerPoint</Application>
  <PresentationFormat>Bildschirmpräsentation 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Ellen Bruske</dc:creator>
  <cp:lastModifiedBy>Ellen Bruske</cp:lastModifiedBy>
  <cp:revision>1</cp:revision>
  <dcterms:created xsi:type="dcterms:W3CDTF">2018-05-20T14:04:08Z</dcterms:created>
  <dcterms:modified xsi:type="dcterms:W3CDTF">2018-05-20T14:12:08Z</dcterms:modified>
</cp:coreProperties>
</file>